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comments/comment1.xml" ContentType="application/vnd.openxmlformats-officedocument.presentationml.comments+xml"/>
  <Override PartName="/ppt/commentAuthors.xml" ContentType="application/vnd.openxmlformats-officedocument.presentationml.commentAuthor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commentAuthors.xml><?xml version="1.0" encoding="utf-8"?>
<p:cmAuthorLst xmlns:p="http://schemas.openxmlformats.org/presentationml/2006/main">
  <p:cmAuthor id="0" name="Ajay Jain" initials="AJ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<Relationship Id="rId5" Type="http://schemas.openxmlformats.org/officeDocument/2006/relationships/commentAuthors" Target="commentAuthors.xml"/>
</Relationships>
</file>

<file path=ppt/comments/comment1.xml><?xml version="1.0" encoding="utf-8"?>
<p:cmLst xmlns:p="http://schemas.openxmlformats.org/presentationml/2006/main">
  <p:cm authorId="0" dt="2011-12-02T17:04:28.593000000" idx="1">
    <p:pos x="5690" y="3299"/>
    <p:text>We dont show this data. Should I remove this text?</p:text>
  </p:cm>
</p:cmLst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E3EB5-24F6-4B81-86E5-E14F50CB1A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2E83E-B05B-4946-A8EC-35C040B486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EDA89-6339-4475-90CC-3B2DDB89B2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41198-4BA5-468E-B06C-481C0234D4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7BFDE-A7FC-4427-BC8A-DB61F4F46A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E72F2-DE17-4416-89DA-44EB9D1FD5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AA189-680F-4D15-8032-365AE0A5F8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0E67B-4D52-4E37-85C2-5DC1CB660C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33F75-FB7E-4BEE-B80C-404630FC8A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C6697-A191-42D6-B276-1A346CB7A6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3675F-B981-4A87-84C9-193C702213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A8831-1D13-479C-AA44-C150B22844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43F398-CBC0-4879-93FE-98C591F92E5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<Relationship Id="rId6" Type="http://schemas.openxmlformats.org/officeDocument/2006/relationships/comments" Target="../comments/commen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35" descr=""/>
          <p:cNvPicPr/>
          <p:nvPr/>
        </p:nvPicPr>
        <p:blipFill>
          <a:blip r:embed="rId1"/>
          <a:stretch/>
        </p:blipFill>
        <p:spPr>
          <a:xfrm>
            <a:off x="5630760" y="1100160"/>
            <a:ext cx="3284640" cy="23004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8"/>
          <p:cNvSpPr/>
          <p:nvPr/>
        </p:nvSpPr>
        <p:spPr>
          <a:xfrm>
            <a:off x="1116000" y="51120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Object 80"/>
          <p:cNvGraphicFramePr/>
          <p:nvPr/>
        </p:nvGraphicFramePr>
        <p:xfrm>
          <a:off x="138240" y="890640"/>
          <a:ext cx="5263920" cy="320040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44" name="Object 80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138240" y="890640"/>
                    <a:ext cx="5263920" cy="320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189"/>
          <p:cNvSpPr/>
          <p:nvPr/>
        </p:nvSpPr>
        <p:spPr>
          <a:xfrm>
            <a:off x="2467080" y="3733920"/>
            <a:ext cx="2290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33"/>
          <p:cNvSpPr/>
          <p:nvPr/>
        </p:nvSpPr>
        <p:spPr>
          <a:xfrm>
            <a:off x="2770200" y="1197000"/>
            <a:ext cx="1111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334"/>
          <p:cNvSpPr/>
          <p:nvPr/>
        </p:nvSpPr>
        <p:spPr>
          <a:xfrm>
            <a:off x="152280" y="3962520"/>
            <a:ext cx="8839440" cy="309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A-2H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an cause an initial drop in platelet count prior to platelet depletion with MWReg30 that may be the result of platelet sequestration by 2A-2Hc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n some, but not all, individual experiments we observed a significant platelet drop 16-24 hours after infusion of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prior to the administration of MWReg30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ice were pretreated with a single IV dose of IgG2a-Fc or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n day 1. Platelet depletion was initiated on day 2 with daily injections of MWReg30. Administration of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aused a drop in platelet count prior to administration of MWReg30 on day 2 in some experiments. Percent drop in platelet count is shown using day 1 rather that day 2 as a baseline in this supplementary figure (*Significant with Bonferroni's post-test, n=11-12/group, data pooled from 2 separate experiments). In order to exclude the possibility of endotoxin contamination, stradomer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T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were tested in an ITP model in TLR-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/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mice, which lack the endotoxin receptor.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1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Stradomer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T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were able to prevent platelet loss in TLR4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/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mice (p = 0.005 and 0.044 at Day 4 and Day 5 respectively, n=6 mice/group, data not shown), suggesting that the protective effects of stradomer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TM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re not due to contaminating endotoxin. Furthermore, we evaluated the possibility that platelet sequestration contributed to initial platelet loss by testing the ability of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to bind to platelets. These studies revealed that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binds MWReg30 positive cells and suggest that transient platelet sequestration might contribute to this initial drop in select animals.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eripheral blood mononuclear cells were doubly stained with PE conjugated MWReg30 and DyLight 488 conjugated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.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WReg30 positive cells with low forward scatter and increased side scatter were gated as platelets. The histogram shows staining of  the gated MWReg30 positive platelet population with 2A-2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dark, no fill) or isotype control  (light, gray fill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515"/>
          <p:cNvSpPr/>
          <p:nvPr/>
        </p:nvSpPr>
        <p:spPr>
          <a:xfrm>
            <a:off x="3824280" y="2187720"/>
            <a:ext cx="320760" cy="44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887"/>
          <p:cNvSpPr/>
          <p:nvPr/>
        </p:nvSpPr>
        <p:spPr>
          <a:xfrm>
            <a:off x="3886200" y="2739960"/>
            <a:ext cx="100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n.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887"/>
          <p:cNvSpPr/>
          <p:nvPr/>
        </p:nvSpPr>
        <p:spPr>
          <a:xfrm>
            <a:off x="4757760" y="2606760"/>
            <a:ext cx="100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n.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oup 25"/>
          <p:cNvGrpSpPr/>
          <p:nvPr/>
        </p:nvGrpSpPr>
        <p:grpSpPr>
          <a:xfrm>
            <a:off x="990720" y="2332080"/>
            <a:ext cx="1135080" cy="1096920"/>
            <a:chOff x="990720" y="2332080"/>
            <a:chExt cx="1135080" cy="1096920"/>
          </a:xfrm>
        </p:grpSpPr>
        <p:grpSp>
          <p:nvGrpSpPr>
            <p:cNvPr id="52" name="Group 21"/>
            <p:cNvGrpSpPr/>
            <p:nvPr/>
          </p:nvGrpSpPr>
          <p:grpSpPr>
            <a:xfrm>
              <a:off x="990720" y="2332080"/>
              <a:ext cx="1135080" cy="1096920"/>
              <a:chOff x="990720" y="2332080"/>
              <a:chExt cx="1135080" cy="1096920"/>
            </a:xfrm>
          </p:grpSpPr>
          <p:pic>
            <p:nvPicPr>
              <p:cNvPr id="53" name="Picture 88" descr=""/>
              <p:cNvPicPr/>
              <p:nvPr/>
            </p:nvPicPr>
            <p:blipFill>
              <a:blip r:embed="rId4"/>
              <a:stretch/>
            </p:blipFill>
            <p:spPr>
              <a:xfrm>
                <a:off x="990720" y="2332080"/>
                <a:ext cx="1135080" cy="1096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4" name="Rectangle 18"/>
              <p:cNvSpPr/>
              <p:nvPr/>
            </p:nvSpPr>
            <p:spPr>
              <a:xfrm>
                <a:off x="1433520" y="3184560"/>
                <a:ext cx="609480" cy="1490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" name="TextBox 19"/>
            <p:cNvSpPr/>
            <p:nvPr/>
          </p:nvSpPr>
          <p:spPr>
            <a:xfrm>
              <a:off x="1336320" y="3105000"/>
              <a:ext cx="761760" cy="31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2A-2H</a:t>
              </a:r>
              <a:r>
                <a:rPr b="0" lang="en-US" sz="13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Text Box 515"/>
          <p:cNvSpPr/>
          <p:nvPr/>
        </p:nvSpPr>
        <p:spPr>
          <a:xfrm>
            <a:off x="4708440" y="2057400"/>
            <a:ext cx="320760" cy="44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89"/>
          <p:cNvSpPr/>
          <p:nvPr/>
        </p:nvSpPr>
        <p:spPr>
          <a:xfrm rot="16200000">
            <a:off x="-1333800" y="2019600"/>
            <a:ext cx="343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%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Y 1 BASELINE PLATELET COU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8"/>
          <p:cNvSpPr/>
          <p:nvPr/>
        </p:nvSpPr>
        <p:spPr>
          <a:xfrm>
            <a:off x="5600880" y="59544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9"/>
          <p:cNvSpPr/>
          <p:nvPr/>
        </p:nvSpPr>
        <p:spPr>
          <a:xfrm>
            <a:off x="0" y="-619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Ajay Jain</cp:lastModifiedBy>
  <cp:lastPrinted>2012-07-16T16:15:58Z</cp:lastPrinted>
  <dcterms:modified xsi:type="dcterms:W3CDTF">2012-08-16T17:33:07Z</dcterms:modified>
  <cp:revision>432</cp:revision>
  <dc:subject/>
  <dc:title>Slide 1</dc:title>
</cp:coreProperties>
</file>